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jpeg" ContentType="image/jpeg"/>
  <Override PartName="/ppt/media/image3.jpeg" ContentType="image/jpeg"/>
  <Override PartName="/ppt/media/image4.jpeg" ContentType="image/jpeg"/>
  <Override PartName="/ppt/media/image5.png" ContentType="image/pn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90367-F343-4C7F-91A3-2538C23ED0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A857DF-9BF4-45D4-A5D7-BB5A8F2F85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1D32D-DE1A-4034-BBFE-AEE6926508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58E81F-8C6F-49AC-B703-86189C13BDE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C9FC3-EFF4-423C-8BDE-7D8474689B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6332E-7801-453F-91AE-F6590D108C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E1155A-4343-4248-BB1F-62BAD8DE81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DAD6B-B3E9-4D94-8192-61DF332A13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6C8D3-3C47-4B0E-A641-8687E502FD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0F750-0927-416F-B431-C73B2EF944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705D55-9AB6-424C-B97D-D00F626948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C2971-1B91-4BDA-A349-6BA3B8325A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5EFEDE-7BAB-4898-A9DA-ED7372CDDE5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image" Target="../media/image3.jpeg"/><Relationship Id="rId3" Type="http://schemas.openxmlformats.org/officeDocument/2006/relationships/image" Target="../media/image4.jpeg"/><Relationship Id="rId4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image" Target="../media/image8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3240"/>
            <a:ext cx="365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406440" y="628560"/>
            <a:ext cx="8229240" cy="3428640"/>
            <a:chOff x="406440" y="628560"/>
            <a:chExt cx="8229240" cy="342864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406440" y="628560"/>
              <a:ext cx="8229240" cy="342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4940280" y="2227680"/>
              <a:ext cx="403560" cy="455400"/>
            </a:xfrm>
            <a:prstGeom prst="rect">
              <a:avLst/>
            </a:prstGeom>
            <a:noFill/>
            <a:ln w="255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"/>
          <p:cNvSpPr/>
          <p:nvPr/>
        </p:nvSpPr>
        <p:spPr>
          <a:xfrm>
            <a:off x="428400" y="324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015920" y="2995560"/>
            <a:ext cx="6275520" cy="343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7" name="" descr=""/>
          <p:cNvPicPr/>
          <p:nvPr/>
        </p:nvPicPr>
        <p:blipFill>
          <a:blip r:embed="rId2"/>
          <a:stretch/>
        </p:blipFill>
        <p:spPr>
          <a:xfrm>
            <a:off x="1015920" y="1795320"/>
            <a:ext cx="6272280" cy="500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8" name="" descr=""/>
          <p:cNvPicPr/>
          <p:nvPr/>
        </p:nvPicPr>
        <p:blipFill>
          <a:blip r:embed="rId3"/>
          <a:stretch/>
        </p:blipFill>
        <p:spPr>
          <a:xfrm>
            <a:off x="1015920" y="2367000"/>
            <a:ext cx="6275520" cy="55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"/>
          <p:cNvSpPr/>
          <p:nvPr/>
        </p:nvSpPr>
        <p:spPr>
          <a:xfrm>
            <a:off x="1422360" y="1486080"/>
            <a:ext cx="589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pcDNA+F-JunB      pcDNA+M-Smurf1      M-Smurf1+F-Ju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117440" y="3336840"/>
            <a:ext cx="629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DMSO    Erk     JNK     DMSO Erk     JNK     DMSO    Erk     JN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428600" y="2584440"/>
            <a:ext cx="67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-Jun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458480" y="1922400"/>
            <a:ext cx="84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M-Smurf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425720" y="3075120"/>
            <a:ext cx="654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117440" y="1724040"/>
            <a:ext cx="1930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149640" y="1724040"/>
            <a:ext cx="1930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181480" y="1724040"/>
            <a:ext cx="1930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04920" y="19080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~ 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04920" y="2651040"/>
            <a:ext cx="107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~ 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04920" y="3051000"/>
            <a:ext cx="107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~ 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06440" y="154296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K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470520" y="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1320840" y="1771560"/>
            <a:ext cx="4368600" cy="2914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3" name=""/>
          <p:cNvSpPr/>
          <p:nvPr/>
        </p:nvSpPr>
        <p:spPr>
          <a:xfrm>
            <a:off x="1523880" y="685800"/>
            <a:ext cx="77216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+   +    -    +    +    +    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Biotin-WT D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ourier New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+    +    +    +    +    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C2C12 nuclear extra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ourier New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-    +    -    -    -    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Biotin-mutant D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ourier New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-    -    +    -    -    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excess of unlabeled  WT DNA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ourier New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-    -    -    +    -    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excess of unlabeled mutant D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ourier New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-    -    -    -    +    -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ourier New"/>
              <a:buChar char="-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SimSun"/>
              </a:rPr>
              <a:t>-    -    -    -    -    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        JunB antibod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994360" y="1771560"/>
            <a:ext cx="182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supershif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5689080" y="1876320"/>
            <a:ext cx="304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"/>
          <p:cNvSpPr/>
          <p:nvPr/>
        </p:nvSpPr>
        <p:spPr>
          <a:xfrm>
            <a:off x="460440" y="0"/>
            <a:ext cx="247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SimSun"/>
              </a:rPr>
              <a:t>Supplemental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" descr=""/>
          <p:cNvPicPr/>
          <p:nvPr/>
        </p:nvPicPr>
        <p:blipFill>
          <a:blip r:embed="rId1"/>
          <a:srcRect l="15568" t="0" r="9492" b="29154"/>
          <a:stretch/>
        </p:blipFill>
        <p:spPr>
          <a:xfrm>
            <a:off x="5384880" y="2343240"/>
            <a:ext cx="3047760" cy="173196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2"/>
          <a:srcRect l="8335" t="0" r="7330" b="29807"/>
          <a:stretch/>
        </p:blipFill>
        <p:spPr>
          <a:xfrm>
            <a:off x="2901960" y="343080"/>
            <a:ext cx="3048120" cy="1584000"/>
          </a:xfrm>
          <a:prstGeom prst="rect">
            <a:avLst/>
          </a:prstGeom>
          <a:ln w="0">
            <a:noFill/>
          </a:ln>
        </p:spPr>
      </p:pic>
      <p:pic>
        <p:nvPicPr>
          <p:cNvPr id="69" name="" descr=""/>
          <p:cNvPicPr/>
          <p:nvPr/>
        </p:nvPicPr>
        <p:blipFill>
          <a:blip r:embed="rId3"/>
          <a:srcRect l="12632" t="0" r="9479" b="29861"/>
          <a:stretch/>
        </p:blipFill>
        <p:spPr>
          <a:xfrm>
            <a:off x="914400" y="2343240"/>
            <a:ext cx="3048120" cy="171432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812880" y="4114800"/>
            <a:ext cx="30477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812880" y="2400480"/>
            <a:ext cx="0" cy="1714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283360" y="4114800"/>
            <a:ext cx="30477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5283360" y="2400480"/>
            <a:ext cx="0" cy="17143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906640" y="1943280"/>
            <a:ext cx="27432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V="1">
            <a:off x="2906640" y="457200"/>
            <a:ext cx="0" cy="1486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106880" y="194328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224440" y="417204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698080" y="4172040"/>
            <a:ext cx="283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APC-Hematopoietic Lineage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rot="16173600">
            <a:off x="2414880" y="754200"/>
            <a:ext cx="52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S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rot="16173600">
            <a:off x="201600" y="2593440"/>
            <a:ext cx="868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FITC-CD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6173600">
            <a:off x="4695840" y="2621880"/>
            <a:ext cx="696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PE-CD1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083120" y="3200400"/>
            <a:ext cx="59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CD45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SimSu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962520" y="3371760"/>
            <a:ext cx="1218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197760" y="1085760"/>
            <a:ext cx="1218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687560" y="1108080"/>
            <a:ext cx="70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62.77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147400" y="3543480"/>
            <a:ext cx="70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20.70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516360" y="2685960"/>
            <a:ext cx="70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SimSun"/>
              </a:rPr>
              <a:t>41.53%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06T21:32:08Z</dcterms:created>
  <dc:creator>afennell</dc:creator>
  <dc:description/>
  <dc:language>en-US</dc:language>
  <cp:lastModifiedBy>afennell</cp:lastModifiedBy>
  <dcterms:modified xsi:type="dcterms:W3CDTF">2010-01-06T21:32:13Z</dcterms:modified>
  <cp:revision>1</cp:revision>
  <dc:subject/>
  <dc:title>Slide 1</dc:title>
</cp:coreProperties>
</file>